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4685"/>
  </p:normalViewPr>
  <p:slideViewPr>
    <p:cSldViewPr snapToGrid="0" snapToObjects="1">
      <p:cViewPr>
        <p:scale>
          <a:sx n="98" d="100"/>
          <a:sy n="98" d="100"/>
        </p:scale>
        <p:origin x="-70" y="2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691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285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956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03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73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556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995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0981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9141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2186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722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7F924B-C7D7-574A-AEA7-43B0260F5606}" type="datetimeFigureOut">
              <a:rPr lang="en-US" smtClean="0"/>
              <a:t>12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5C0DF-A16D-8C48-A1AF-7A57283C5C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6215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B0FE90E7-3CDD-634D-A8A2-FA274DE76569}"/>
              </a:ext>
            </a:extLst>
          </p:cNvPr>
          <p:cNvSpPr txBox="1"/>
          <p:nvPr/>
        </p:nvSpPr>
        <p:spPr>
          <a:xfrm>
            <a:off x="0" y="15113"/>
            <a:ext cx="119930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aw images of Western blot: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ntibody was purchased from Sigma and showed presence of multiple non-specific bands at higher and lower molecular weight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="" xmlns:a16="http://schemas.microsoft.com/office/drawing/2014/main" id="{AEF1A124-2E7C-5348-98CE-AB51C8786CF9}"/>
              </a:ext>
            </a:extLst>
          </p:cNvPr>
          <p:cNvGrpSpPr/>
          <p:nvPr/>
        </p:nvGrpSpPr>
        <p:grpSpPr>
          <a:xfrm>
            <a:off x="8271460" y="857351"/>
            <a:ext cx="3629047" cy="5890253"/>
            <a:chOff x="8350955" y="604431"/>
            <a:chExt cx="3629047" cy="5890253"/>
          </a:xfrm>
        </p:grpSpPr>
        <p:sp>
          <p:nvSpPr>
            <p:cNvPr id="21" name="TextBox 20">
              <a:extLst>
                <a:ext uri="{FF2B5EF4-FFF2-40B4-BE49-F238E27FC236}">
                  <a16:creationId xmlns="" xmlns:a16="http://schemas.microsoft.com/office/drawing/2014/main" id="{2B10BB4D-E970-084C-AA29-0E41A44A5824}"/>
                </a:ext>
              </a:extLst>
            </p:cNvPr>
            <p:cNvSpPr txBox="1"/>
            <p:nvPr/>
          </p:nvSpPr>
          <p:spPr>
            <a:xfrm>
              <a:off x="9266440" y="604431"/>
              <a:ext cx="12603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ti tubulin</a:t>
              </a:r>
            </a:p>
          </p:txBody>
        </p:sp>
        <p:pic>
          <p:nvPicPr>
            <p:cNvPr id="23" name="Picture 22">
              <a:extLst>
                <a:ext uri="{FF2B5EF4-FFF2-40B4-BE49-F238E27FC236}">
                  <a16:creationId xmlns="" xmlns:a16="http://schemas.microsoft.com/office/drawing/2014/main" id="{F1CD209D-42CD-C749-81C0-A13624AFE6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9001285" y="1389284"/>
              <a:ext cx="1790700" cy="5105400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="" xmlns:a16="http://schemas.microsoft.com/office/drawing/2014/main" id="{9D40E86E-2FB9-A045-99B5-10DF522537A7}"/>
                </a:ext>
              </a:extLst>
            </p:cNvPr>
            <p:cNvSpPr txBox="1"/>
            <p:nvPr/>
          </p:nvSpPr>
          <p:spPr>
            <a:xfrm>
              <a:off x="8375736" y="1893815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60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="" xmlns:a16="http://schemas.microsoft.com/office/drawing/2014/main" id="{E17F7995-DE51-174F-B4E0-FD337D486D2C}"/>
                </a:ext>
              </a:extLst>
            </p:cNvPr>
            <p:cNvSpPr txBox="1"/>
            <p:nvPr/>
          </p:nvSpPr>
          <p:spPr>
            <a:xfrm>
              <a:off x="8350955" y="1412125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="" xmlns:a16="http://schemas.microsoft.com/office/drawing/2014/main" id="{6BA33FFB-AA00-F540-AD91-922113BFBD6C}"/>
                </a:ext>
              </a:extLst>
            </p:cNvPr>
            <p:cNvSpPr txBox="1"/>
            <p:nvPr/>
          </p:nvSpPr>
          <p:spPr>
            <a:xfrm>
              <a:off x="8375736" y="2870526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60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="" xmlns:a16="http://schemas.microsoft.com/office/drawing/2014/main" id="{6573296E-3E2F-BA48-99E2-7A47AD43542E}"/>
                </a:ext>
              </a:extLst>
            </p:cNvPr>
            <p:cNvSpPr txBox="1"/>
            <p:nvPr/>
          </p:nvSpPr>
          <p:spPr>
            <a:xfrm>
              <a:off x="8399222" y="3275111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="" xmlns:a16="http://schemas.microsoft.com/office/drawing/2014/main" id="{62B21A42-401E-AA44-A0D0-CB772E04AF7C}"/>
                </a:ext>
              </a:extLst>
            </p:cNvPr>
            <p:cNvSpPr txBox="1"/>
            <p:nvPr/>
          </p:nvSpPr>
          <p:spPr>
            <a:xfrm>
              <a:off x="8525832" y="4477263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="" xmlns:a16="http://schemas.microsoft.com/office/drawing/2014/main" id="{F37F4CD5-451D-8C4B-9B04-D3621EB36A11}"/>
                </a:ext>
              </a:extLst>
            </p:cNvPr>
            <p:cNvSpPr txBox="1"/>
            <p:nvPr/>
          </p:nvSpPr>
          <p:spPr>
            <a:xfrm>
              <a:off x="8525832" y="5584474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="" xmlns:a16="http://schemas.microsoft.com/office/drawing/2014/main" id="{4C8AB8DB-7D49-C647-8467-3A9FB818037F}"/>
                </a:ext>
              </a:extLst>
            </p:cNvPr>
            <p:cNvSpPr txBox="1"/>
            <p:nvPr/>
          </p:nvSpPr>
          <p:spPr>
            <a:xfrm>
              <a:off x="10719613" y="4324117"/>
              <a:ext cx="12603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nti tubulin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="" xmlns:a16="http://schemas.microsoft.com/office/drawing/2014/main" id="{028D93DC-1DA0-9F44-A290-1FA62888CE6D}"/>
              </a:ext>
            </a:extLst>
          </p:cNvPr>
          <p:cNvGrpSpPr/>
          <p:nvPr/>
        </p:nvGrpSpPr>
        <p:grpSpPr>
          <a:xfrm>
            <a:off x="1094971" y="959825"/>
            <a:ext cx="4502508" cy="5787779"/>
            <a:chOff x="1191604" y="704345"/>
            <a:chExt cx="4502508" cy="5787779"/>
          </a:xfrm>
        </p:grpSpPr>
        <p:sp>
          <p:nvSpPr>
            <p:cNvPr id="5" name="TextBox 4">
              <a:extLst>
                <a:ext uri="{FF2B5EF4-FFF2-40B4-BE49-F238E27FC236}">
                  <a16:creationId xmlns="" xmlns:a16="http://schemas.microsoft.com/office/drawing/2014/main" id="{D9E79127-7C9B-9D44-93B3-EE39E5407DF9}"/>
                </a:ext>
              </a:extLst>
            </p:cNvPr>
            <p:cNvSpPr txBox="1"/>
            <p:nvPr/>
          </p:nvSpPr>
          <p:spPr>
            <a:xfrm>
              <a:off x="1191604" y="2016535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260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945EDA65-78D4-264F-8635-C3689B6A65C0}"/>
                </a:ext>
              </a:extLst>
            </p:cNvPr>
            <p:cNvSpPr txBox="1"/>
            <p:nvPr/>
          </p:nvSpPr>
          <p:spPr>
            <a:xfrm>
              <a:off x="1191604" y="1491219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9D89667D-6B52-7D4B-8323-BE3C779327C6}"/>
                </a:ext>
              </a:extLst>
            </p:cNvPr>
            <p:cNvSpPr txBox="1"/>
            <p:nvPr/>
          </p:nvSpPr>
          <p:spPr>
            <a:xfrm>
              <a:off x="1199898" y="2935458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60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220BEB86-8420-5C4D-A608-7EB90DF30944}"/>
                </a:ext>
              </a:extLst>
            </p:cNvPr>
            <p:cNvSpPr txBox="1"/>
            <p:nvPr/>
          </p:nvSpPr>
          <p:spPr>
            <a:xfrm>
              <a:off x="1199898" y="3371427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1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42E4206E-73E7-7447-8C1B-DB1BA9284067}"/>
                </a:ext>
              </a:extLst>
            </p:cNvPr>
            <p:cNvSpPr txBox="1"/>
            <p:nvPr/>
          </p:nvSpPr>
          <p:spPr>
            <a:xfrm>
              <a:off x="1281059" y="4543529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BD02249A-DE08-DD49-9731-7647D765B814}"/>
                </a:ext>
              </a:extLst>
            </p:cNvPr>
            <p:cNvSpPr txBox="1"/>
            <p:nvPr/>
          </p:nvSpPr>
          <p:spPr>
            <a:xfrm>
              <a:off x="1281059" y="5633022"/>
              <a:ext cx="77199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E9C9D27F-2CF3-0744-8561-1404146B42E6}"/>
                </a:ext>
              </a:extLst>
            </p:cNvPr>
            <p:cNvSpPr txBox="1"/>
            <p:nvPr/>
          </p:nvSpPr>
          <p:spPr>
            <a:xfrm>
              <a:off x="3670254" y="4016340"/>
              <a:ext cx="12603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anti ZNF180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="" xmlns:a16="http://schemas.microsoft.com/office/drawing/2014/main" id="{E9A67E79-A854-9342-A98D-80E64567890D}"/>
                </a:ext>
              </a:extLst>
            </p:cNvPr>
            <p:cNvSpPr txBox="1"/>
            <p:nvPr/>
          </p:nvSpPr>
          <p:spPr>
            <a:xfrm>
              <a:off x="2769929" y="704345"/>
              <a:ext cx="12603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nti ZNF180</a:t>
              </a:r>
            </a:p>
          </p:txBody>
        </p:sp>
        <p:pic>
          <p:nvPicPr>
            <p:cNvPr id="24" name="Picture 23">
              <a:extLst>
                <a:ext uri="{FF2B5EF4-FFF2-40B4-BE49-F238E27FC236}">
                  <a16:creationId xmlns="" xmlns:a16="http://schemas.microsoft.com/office/drawing/2014/main" id="{B96E8A5C-3CFC-7E4C-9D8D-33C76A0A644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rot="16200000" flipH="1">
              <a:off x="388425" y="3348159"/>
              <a:ext cx="4538323" cy="1749608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="" xmlns:a16="http://schemas.microsoft.com/office/drawing/2014/main" id="{956639C9-34B9-2446-A934-3DCAB1297488}"/>
                </a:ext>
              </a:extLst>
            </p:cNvPr>
            <p:cNvSpPr txBox="1"/>
            <p:nvPr/>
          </p:nvSpPr>
          <p:spPr>
            <a:xfrm>
              <a:off x="3718570" y="3089346"/>
              <a:ext cx="197554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on-specific bands</a:t>
              </a:r>
            </a:p>
          </p:txBody>
        </p:sp>
        <p:cxnSp>
          <p:nvCxnSpPr>
            <p:cNvPr id="34" name="Straight Connector 33">
              <a:extLst>
                <a:ext uri="{FF2B5EF4-FFF2-40B4-BE49-F238E27FC236}">
                  <a16:creationId xmlns="" xmlns:a16="http://schemas.microsoft.com/office/drawing/2014/main" id="{FC6642C2-2127-9046-A6E3-4CD8D0FFACCB}"/>
                </a:ext>
              </a:extLst>
            </p:cNvPr>
            <p:cNvCxnSpPr/>
            <p:nvPr/>
          </p:nvCxnSpPr>
          <p:spPr>
            <a:xfrm>
              <a:off x="3670254" y="2984886"/>
              <a:ext cx="0" cy="49354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F5DC0D11-06EA-2241-B173-111898F1A99A}"/>
              </a:ext>
            </a:extLst>
          </p:cNvPr>
          <p:cNvSpPr txBox="1"/>
          <p:nvPr/>
        </p:nvSpPr>
        <p:spPr>
          <a:xfrm rot="18947766">
            <a:off x="2409363" y="1590250"/>
            <a:ext cx="966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NT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33097F76-ED9E-7345-AE20-821EFF8115DA}"/>
              </a:ext>
            </a:extLst>
          </p:cNvPr>
          <p:cNvSpPr txBox="1"/>
          <p:nvPr/>
        </p:nvSpPr>
        <p:spPr>
          <a:xfrm rot="18947766">
            <a:off x="2948333" y="1602764"/>
            <a:ext cx="1109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ZNF180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B3878D06-BC38-3147-9AAA-447CB395D871}"/>
              </a:ext>
            </a:extLst>
          </p:cNvPr>
          <p:cNvSpPr txBox="1"/>
          <p:nvPr/>
        </p:nvSpPr>
        <p:spPr>
          <a:xfrm rot="18947766">
            <a:off x="8941111" y="1229948"/>
            <a:ext cx="9663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shNTC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773E5879-0A96-E540-85EC-8A530D21A778}"/>
              </a:ext>
            </a:extLst>
          </p:cNvPr>
          <p:cNvSpPr txBox="1"/>
          <p:nvPr/>
        </p:nvSpPr>
        <p:spPr>
          <a:xfrm rot="18947766">
            <a:off x="9640133" y="1229947"/>
            <a:ext cx="11090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hZNF180</a:t>
            </a:r>
          </a:p>
        </p:txBody>
      </p:sp>
    </p:spTree>
    <p:extLst>
      <p:ext uri="{BB962C8B-B14F-4D97-AF65-F5344CB8AC3E}">
        <p14:creationId xmlns:p14="http://schemas.microsoft.com/office/powerpoint/2010/main" val="11152152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50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aveen agrawal</dc:creator>
  <cp:lastModifiedBy>Song, Won-min</cp:lastModifiedBy>
  <cp:revision>31</cp:revision>
  <dcterms:created xsi:type="dcterms:W3CDTF">2020-07-06T12:00:04Z</dcterms:created>
  <dcterms:modified xsi:type="dcterms:W3CDTF">2020-12-22T20:39:46Z</dcterms:modified>
</cp:coreProperties>
</file>